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59" r:id="rId3"/>
    <p:sldId id="260" r:id="rId4"/>
    <p:sldId id="256" r:id="rId5"/>
  </p:sldIdLst>
  <p:sldSz cx="6858000" cy="9906000" type="A4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ción predeterminada" id="{2A3C0A39-A9C9-4A48-88F8-977A4652BAA4}">
          <p14:sldIdLst>
            <p14:sldId id="258"/>
            <p14:sldId id="259"/>
            <p14:sldId id="260"/>
            <p14:sldId id="25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31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43" indent="0" algn="ctr">
              <a:buNone/>
              <a:defRPr sz="1499"/>
            </a:lvl2pPr>
            <a:lvl3pPr marL="685685" indent="0" algn="ctr">
              <a:buNone/>
              <a:defRPr sz="1351"/>
            </a:lvl3pPr>
            <a:lvl4pPr marL="1028527" indent="0" algn="ctr">
              <a:buNone/>
              <a:defRPr sz="1200"/>
            </a:lvl4pPr>
            <a:lvl5pPr marL="1371372" indent="0" algn="ctr">
              <a:buNone/>
              <a:defRPr sz="1200"/>
            </a:lvl5pPr>
            <a:lvl6pPr marL="1714213" indent="0" algn="ctr">
              <a:buNone/>
              <a:defRPr sz="1200"/>
            </a:lvl6pPr>
            <a:lvl7pPr marL="2057056" indent="0" algn="ctr">
              <a:buNone/>
              <a:defRPr sz="1200"/>
            </a:lvl7pPr>
            <a:lvl8pPr marL="2399897" indent="0" algn="ctr">
              <a:buNone/>
              <a:defRPr sz="1200"/>
            </a:lvl8pPr>
            <a:lvl9pPr marL="274274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9306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9411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2682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8210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20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20" y="6629232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43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685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5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37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21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0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39989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7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49115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2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5" y="527406"/>
            <a:ext cx="5915025" cy="1914702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3" indent="0">
              <a:buNone/>
              <a:defRPr sz="1499" b="1"/>
            </a:lvl2pPr>
            <a:lvl3pPr marL="685685" indent="0">
              <a:buNone/>
              <a:defRPr sz="1351" b="1"/>
            </a:lvl3pPr>
            <a:lvl4pPr marL="1028527" indent="0">
              <a:buNone/>
              <a:defRPr sz="1200" b="1"/>
            </a:lvl4pPr>
            <a:lvl5pPr marL="1371372" indent="0">
              <a:buNone/>
              <a:defRPr sz="1200" b="1"/>
            </a:lvl5pPr>
            <a:lvl6pPr marL="1714213" indent="0">
              <a:buNone/>
              <a:defRPr sz="1200" b="1"/>
            </a:lvl6pPr>
            <a:lvl7pPr marL="2057056" indent="0">
              <a:buNone/>
              <a:defRPr sz="1200" b="1"/>
            </a:lvl7pPr>
            <a:lvl8pPr marL="2399897" indent="0">
              <a:buNone/>
              <a:defRPr sz="1200" b="1"/>
            </a:lvl8pPr>
            <a:lvl9pPr marL="274274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43" indent="0">
              <a:buNone/>
              <a:defRPr sz="1499" b="1"/>
            </a:lvl2pPr>
            <a:lvl3pPr marL="685685" indent="0">
              <a:buNone/>
              <a:defRPr sz="1351" b="1"/>
            </a:lvl3pPr>
            <a:lvl4pPr marL="1028527" indent="0">
              <a:buNone/>
              <a:defRPr sz="1200" b="1"/>
            </a:lvl4pPr>
            <a:lvl5pPr marL="1371372" indent="0">
              <a:buNone/>
              <a:defRPr sz="1200" b="1"/>
            </a:lvl5pPr>
            <a:lvl6pPr marL="1714213" indent="0">
              <a:buNone/>
              <a:defRPr sz="1200" b="1"/>
            </a:lvl6pPr>
            <a:lvl7pPr marL="2057056" indent="0">
              <a:buNone/>
              <a:defRPr sz="1200" b="1"/>
            </a:lvl7pPr>
            <a:lvl8pPr marL="2399897" indent="0">
              <a:buNone/>
              <a:defRPr sz="1200" b="1"/>
            </a:lvl8pPr>
            <a:lvl9pPr marL="274274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7989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53893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5182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7" y="1426288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3" indent="0">
              <a:buNone/>
              <a:defRPr sz="1050"/>
            </a:lvl2pPr>
            <a:lvl3pPr marL="685685" indent="0">
              <a:buNone/>
              <a:defRPr sz="900"/>
            </a:lvl3pPr>
            <a:lvl4pPr marL="1028527" indent="0">
              <a:buNone/>
              <a:defRPr sz="750"/>
            </a:lvl4pPr>
            <a:lvl5pPr marL="1371372" indent="0">
              <a:buNone/>
              <a:defRPr sz="750"/>
            </a:lvl5pPr>
            <a:lvl6pPr marL="1714213" indent="0">
              <a:buNone/>
              <a:defRPr sz="750"/>
            </a:lvl6pPr>
            <a:lvl7pPr marL="2057056" indent="0">
              <a:buNone/>
              <a:defRPr sz="750"/>
            </a:lvl7pPr>
            <a:lvl8pPr marL="2399897" indent="0">
              <a:buNone/>
              <a:defRPr sz="750"/>
            </a:lvl8pPr>
            <a:lvl9pPr marL="274274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48960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7" y="1426288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43" indent="0">
              <a:buNone/>
              <a:defRPr sz="2100"/>
            </a:lvl2pPr>
            <a:lvl3pPr marL="685685" indent="0">
              <a:buNone/>
              <a:defRPr sz="1800"/>
            </a:lvl3pPr>
            <a:lvl4pPr marL="1028527" indent="0">
              <a:buNone/>
              <a:defRPr sz="1499"/>
            </a:lvl4pPr>
            <a:lvl5pPr marL="1371372" indent="0">
              <a:buNone/>
              <a:defRPr sz="1499"/>
            </a:lvl5pPr>
            <a:lvl6pPr marL="1714213" indent="0">
              <a:buNone/>
              <a:defRPr sz="1499"/>
            </a:lvl6pPr>
            <a:lvl7pPr marL="2057056" indent="0">
              <a:buNone/>
              <a:defRPr sz="1499"/>
            </a:lvl7pPr>
            <a:lvl8pPr marL="2399897" indent="0">
              <a:buNone/>
              <a:defRPr sz="1499"/>
            </a:lvl8pPr>
            <a:lvl9pPr marL="2742740" indent="0">
              <a:buNone/>
              <a:defRPr sz="1499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43" indent="0">
              <a:buNone/>
              <a:defRPr sz="1050"/>
            </a:lvl2pPr>
            <a:lvl3pPr marL="685685" indent="0">
              <a:buNone/>
              <a:defRPr sz="900"/>
            </a:lvl3pPr>
            <a:lvl4pPr marL="1028527" indent="0">
              <a:buNone/>
              <a:defRPr sz="750"/>
            </a:lvl4pPr>
            <a:lvl5pPr marL="1371372" indent="0">
              <a:buNone/>
              <a:defRPr sz="750"/>
            </a:lvl5pPr>
            <a:lvl6pPr marL="1714213" indent="0">
              <a:buNone/>
              <a:defRPr sz="750"/>
            </a:lvl6pPr>
            <a:lvl7pPr marL="2057056" indent="0">
              <a:buNone/>
              <a:defRPr sz="750"/>
            </a:lvl7pPr>
            <a:lvl8pPr marL="2399897" indent="0">
              <a:buNone/>
              <a:defRPr sz="750"/>
            </a:lvl8pPr>
            <a:lvl9pPr marL="274274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56239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2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2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2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F8174-8011-4F35-98ED-9FDC9C9DDEDA}" type="datetimeFigureOut">
              <a:rPr lang="es-ES" smtClean="0"/>
              <a:t>13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7" y="9181402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2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782A51-6CF5-4042-9ECD-9DDA421CD95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84212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685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22" indent="-171422" algn="l" defTabSz="685685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263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06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199949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791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634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478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321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162" indent="-171422" algn="l" defTabSz="685685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685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43" algn="l" defTabSz="685685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685" algn="l" defTabSz="685685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527" algn="l" defTabSz="685685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372" algn="l" defTabSz="685685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213" algn="l" defTabSz="685685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056" algn="l" defTabSz="685685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399897" algn="l" defTabSz="685685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740" algn="l" defTabSz="685685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6846453"/>
              </p:ext>
            </p:extLst>
          </p:nvPr>
        </p:nvGraphicFramePr>
        <p:xfrm>
          <a:off x="388427" y="1483709"/>
          <a:ext cx="6081146" cy="1434259"/>
        </p:xfrm>
        <a:graphic>
          <a:graphicData uri="http://schemas.openxmlformats.org/drawingml/2006/table">
            <a:tbl>
              <a:tblPr firstRow="1" firstCol="1" bandRow="1"/>
              <a:tblGrid>
                <a:gridCol w="124177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8393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768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imer name</a:t>
                      </a:r>
                      <a:endParaRPr lang="es-E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quence (5’-3’)</a:t>
                      </a:r>
                      <a:endParaRPr lang="es-E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51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tY-vp2-F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ATCGAATTCGCGGCCGCT</a:t>
                      </a:r>
                      <a:r>
                        <a:rPr lang="en-US" sz="1200">
                          <a:solidFill>
                            <a:srgbClr val="ED7D31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CTAGA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AGGAGGTG</a:t>
                      </a:r>
                      <a:r>
                        <a:rPr lang="en-US" sz="1200">
                          <a:solidFill>
                            <a:srgbClr val="4472C4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CGGC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GAACACAAACAAGGCAACCGCA</a:t>
                      </a:r>
                      <a:endParaRPr lang="es-E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51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tY-vp2-R</a:t>
                      </a:r>
                      <a:endParaRPr lang="es-E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GCTCTGCAGCGGCCGCT</a:t>
                      </a:r>
                      <a:r>
                        <a:rPr lang="en-US" sz="1200" dirty="0">
                          <a:solidFill>
                            <a:srgbClr val="7030A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TAGT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TA</a:t>
                      </a:r>
                      <a:r>
                        <a:rPr lang="en-US" sz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CGGT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GCCATTGGAAACAGCGTGGACAGT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786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myE-F</a:t>
                      </a:r>
                      <a:endParaRPr lang="es-E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GGTTTGAAAGGAGGAAGCGGAAGAATG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2786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myE</a:t>
                      </a: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R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AGCCAGGCTGATTCTGACCGGGCAG</a:t>
                      </a:r>
                      <a:endParaRPr lang="es-E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7" name="Rectángulo 6"/>
          <p:cNvSpPr/>
          <p:nvPr/>
        </p:nvSpPr>
        <p:spPr>
          <a:xfrm>
            <a:off x="362543" y="583822"/>
            <a:ext cx="620335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.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ist of oligonucleotide primers used in this study to translationally fuse the VP2 protein to </a:t>
            </a:r>
            <a:r>
              <a:rPr lang="en-US" sz="1200" dirty="0" err="1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tY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Native or introduced restriction sites are indicated in different colors (</a:t>
            </a:r>
            <a:r>
              <a:rPr lang="en-US" sz="1200" i="1" dirty="0" err="1" smtClean="0">
                <a:solidFill>
                  <a:srgbClr val="4472C4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goM</a:t>
            </a:r>
            <a:r>
              <a:rPr lang="en-US" sz="1200" dirty="0" err="1" smtClean="0">
                <a:solidFill>
                  <a:srgbClr val="4472C4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V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 err="1" smtClean="0">
                <a:solidFill>
                  <a:srgbClr val="ED7D3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Xba</a:t>
            </a:r>
            <a:r>
              <a:rPr lang="en-US" sz="1200" dirty="0" err="1" smtClean="0">
                <a:solidFill>
                  <a:srgbClr val="ED7D3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 err="1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ge</a:t>
            </a:r>
            <a:r>
              <a:rPr lang="en-US" sz="1200" dirty="0" err="1" smtClean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i="1" dirty="0" err="1" smtClean="0">
                <a:solidFill>
                  <a:srgbClr val="7030A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e</a:t>
            </a:r>
            <a:r>
              <a:rPr lang="en-US" sz="1200" dirty="0" err="1" smtClean="0">
                <a:solidFill>
                  <a:srgbClr val="7030A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endParaRPr lang="es-E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87384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/>
          <p:cNvSpPr/>
          <p:nvPr/>
        </p:nvSpPr>
        <p:spPr>
          <a:xfrm>
            <a:off x="223086" y="749666"/>
            <a:ext cx="4998804" cy="28027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Table S2.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st of oligonucleotide primers used in this study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for real-time PCR</a:t>
            </a:r>
            <a:endParaRPr lang="es-E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5" name="Tabla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58556753"/>
              </p:ext>
            </p:extLst>
          </p:nvPr>
        </p:nvGraphicFramePr>
        <p:xfrm>
          <a:off x="238543" y="1476857"/>
          <a:ext cx="6380914" cy="3768239"/>
        </p:xfrm>
        <a:graphic>
          <a:graphicData uri="http://schemas.openxmlformats.org/drawingml/2006/table">
            <a:tbl>
              <a:tblPr/>
              <a:tblGrid>
                <a:gridCol w="71671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95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68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61518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en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orward prim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verse prime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F-1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α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TCCAGAAGGAGGTCACC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TACGTTCGACCTTCCATC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-1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β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CATGGTGCGTTTCCTT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CGGTTTGGTGTAGTCCT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NF-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α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CACACACTGGGCTCTTC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TCCGAATAGCGCCAAATA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L-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TGCTGGACGAAGGGATTCTA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GCCTTTATCCTGCATCTTCT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TH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CAGCTCCAAGTCAAGACTTTGA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GTCCGAATCTTCTGCTGCA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TH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ATGGAGGCAGAAGTTCAGAAGA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GCCAAACCCAGGACGAG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epcidin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CTGTTCCTTTCTCCGAGGTG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TGACAGCAGTTGCAGCACC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g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GCGTGTTTGAGAACAAAG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ACGGCTCGATGATCGTAA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g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CTACATGGGAGTCAGTCAA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TTCGATCCTACCTCCAGTTCC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g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ACATCACCTGGCACATCA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TCAGGTTGCCCTTTGATT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FN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AAACTGTTTGATGGGAATATGAA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GTTTCAGTCTCCTCTCAGGT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CTCAAACGCCTGATGA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CCCCACTGAAACACACCT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49631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LR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CCCTTTGCTGCCTTACAGA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TCTTCAGGTCATTTTTGGACAC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61518"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DA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GAGCCCGTCCAAAGTGAAGT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TTCAGCATAGTCAAAGGCAGGTA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26732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0553" y="1057565"/>
            <a:ext cx="1534305" cy="1636282"/>
          </a:xfrm>
          <a:prstGeom prst="rect">
            <a:avLst/>
          </a:prstGeom>
        </p:spPr>
      </p:pic>
      <p:pic>
        <p:nvPicPr>
          <p:cNvPr id="21" name="Imagen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96764" y="1057565"/>
            <a:ext cx="1501856" cy="1636282"/>
          </a:xfrm>
          <a:prstGeom prst="rect">
            <a:avLst/>
          </a:prstGeom>
        </p:spPr>
      </p:pic>
      <p:sp>
        <p:nvSpPr>
          <p:cNvPr id="24" name="CuadroTexto 23"/>
          <p:cNvSpPr txBox="1"/>
          <p:nvPr/>
        </p:nvSpPr>
        <p:spPr>
          <a:xfrm>
            <a:off x="665986" y="759229"/>
            <a:ext cx="10086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CuadroTexto 24"/>
          <p:cNvSpPr txBox="1"/>
          <p:nvPr/>
        </p:nvSpPr>
        <p:spPr>
          <a:xfrm>
            <a:off x="2425245" y="759229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nglets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uadroTexto 25"/>
          <p:cNvSpPr txBox="1"/>
          <p:nvPr/>
        </p:nvSpPr>
        <p:spPr>
          <a:xfrm>
            <a:off x="4069662" y="759229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ive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uadroTexto 26"/>
          <p:cNvSpPr txBox="1"/>
          <p:nvPr/>
        </p:nvSpPr>
        <p:spPr>
          <a:xfrm>
            <a:off x="5716641" y="759229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  <a:r>
              <a:rPr lang="es-ES" sz="10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s-ES" sz="10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" name="Grupo 41"/>
          <p:cNvGrpSpPr/>
          <p:nvPr/>
        </p:nvGrpSpPr>
        <p:grpSpPr>
          <a:xfrm>
            <a:off x="193227" y="1238540"/>
            <a:ext cx="1408985" cy="1579646"/>
            <a:chOff x="-2494835" y="1181890"/>
            <a:chExt cx="1408985" cy="1579646"/>
          </a:xfrm>
        </p:grpSpPr>
        <p:cxnSp>
          <p:nvCxnSpPr>
            <p:cNvPr id="36" name="Conector recto de flecha 35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ector recto de flecha 38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CuadroTexto 39"/>
            <p:cNvSpPr txBox="1"/>
            <p:nvPr/>
          </p:nvSpPr>
          <p:spPr>
            <a:xfrm rot="16200000">
              <a:off x="-2659624" y="1787047"/>
              <a:ext cx="57579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CuadroTexto 40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3" name="Grupo 42"/>
          <p:cNvGrpSpPr/>
          <p:nvPr/>
        </p:nvGrpSpPr>
        <p:grpSpPr>
          <a:xfrm>
            <a:off x="1860101" y="1238540"/>
            <a:ext cx="1408986" cy="1579646"/>
            <a:chOff x="-2494836" y="1181890"/>
            <a:chExt cx="1408986" cy="1579646"/>
          </a:xfrm>
        </p:grpSpPr>
        <p:cxnSp>
          <p:nvCxnSpPr>
            <p:cNvPr id="44" name="Conector recto de flecha 43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Conector recto de flecha 44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CuadroTexto 45"/>
            <p:cNvSpPr txBox="1"/>
            <p:nvPr/>
          </p:nvSpPr>
          <p:spPr>
            <a:xfrm rot="16200000">
              <a:off x="-2660426" y="1787047"/>
              <a:ext cx="57740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CuadroTexto 46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" name="Imagen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83409" y="1057565"/>
            <a:ext cx="1534305" cy="1636282"/>
          </a:xfrm>
          <a:prstGeom prst="rect">
            <a:avLst/>
          </a:prstGeom>
        </p:spPr>
      </p:pic>
      <p:grpSp>
        <p:nvGrpSpPr>
          <p:cNvPr id="48" name="Grupo 47"/>
          <p:cNvGrpSpPr/>
          <p:nvPr/>
        </p:nvGrpSpPr>
        <p:grpSpPr>
          <a:xfrm>
            <a:off x="3456491" y="1238540"/>
            <a:ext cx="1408986" cy="1579646"/>
            <a:chOff x="-2494836" y="1181890"/>
            <a:chExt cx="1408986" cy="1579646"/>
          </a:xfrm>
        </p:grpSpPr>
        <p:cxnSp>
          <p:nvCxnSpPr>
            <p:cNvPr id="49" name="Conector recto de flecha 48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ector recto de flecha 49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CuadroTexto 51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CuadroTexto 50"/>
            <p:cNvSpPr txBox="1"/>
            <p:nvPr/>
          </p:nvSpPr>
          <p:spPr>
            <a:xfrm rot="16200000">
              <a:off x="-2613137" y="1787047"/>
              <a:ext cx="4828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5" name="Imagen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64654" y="1057565"/>
            <a:ext cx="1501856" cy="1636282"/>
          </a:xfrm>
          <a:prstGeom prst="rect">
            <a:avLst/>
          </a:prstGeom>
        </p:spPr>
      </p:pic>
      <p:grpSp>
        <p:nvGrpSpPr>
          <p:cNvPr id="53" name="Grupo 52"/>
          <p:cNvGrpSpPr/>
          <p:nvPr/>
        </p:nvGrpSpPr>
        <p:grpSpPr>
          <a:xfrm>
            <a:off x="5066216" y="1238540"/>
            <a:ext cx="1408986" cy="1579646"/>
            <a:chOff x="-2494836" y="1181890"/>
            <a:chExt cx="1408986" cy="1579646"/>
          </a:xfrm>
        </p:grpSpPr>
        <p:cxnSp>
          <p:nvCxnSpPr>
            <p:cNvPr id="54" name="Conector recto de flecha 53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ector recto de flecha 54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CuadroTexto 55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CuadroTexto 56"/>
            <p:cNvSpPr txBox="1"/>
            <p:nvPr/>
          </p:nvSpPr>
          <p:spPr>
            <a:xfrm rot="16200000">
              <a:off x="-2570658" y="1787047"/>
              <a:ext cx="39786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3" name="Grupo 62"/>
          <p:cNvGrpSpPr/>
          <p:nvPr/>
        </p:nvGrpSpPr>
        <p:grpSpPr>
          <a:xfrm>
            <a:off x="201245" y="3171622"/>
            <a:ext cx="1408985" cy="1579646"/>
            <a:chOff x="-2494835" y="1181890"/>
            <a:chExt cx="1408985" cy="1579646"/>
          </a:xfrm>
        </p:grpSpPr>
        <p:cxnSp>
          <p:nvCxnSpPr>
            <p:cNvPr id="64" name="Conector recto de flecha 63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ector recto de flecha 64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CuadroTexto 65"/>
            <p:cNvSpPr txBox="1"/>
            <p:nvPr/>
          </p:nvSpPr>
          <p:spPr>
            <a:xfrm rot="16200000">
              <a:off x="-2659624" y="1787047"/>
              <a:ext cx="57579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CuadroTexto 66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8" name="Grupo 67"/>
          <p:cNvGrpSpPr/>
          <p:nvPr/>
        </p:nvGrpSpPr>
        <p:grpSpPr>
          <a:xfrm>
            <a:off x="1868119" y="3171622"/>
            <a:ext cx="1408986" cy="1579646"/>
            <a:chOff x="-2494836" y="1181890"/>
            <a:chExt cx="1408986" cy="1579646"/>
          </a:xfrm>
        </p:grpSpPr>
        <p:cxnSp>
          <p:nvCxnSpPr>
            <p:cNvPr id="69" name="Conector recto de flecha 68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Conector recto de flecha 69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CuadroTexto 70"/>
            <p:cNvSpPr txBox="1"/>
            <p:nvPr/>
          </p:nvSpPr>
          <p:spPr>
            <a:xfrm rot="16200000">
              <a:off x="-2660426" y="1787047"/>
              <a:ext cx="57740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CuadroTexto 71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3" name="Grupo 72"/>
          <p:cNvGrpSpPr/>
          <p:nvPr/>
        </p:nvGrpSpPr>
        <p:grpSpPr>
          <a:xfrm>
            <a:off x="3464509" y="3171622"/>
            <a:ext cx="1408986" cy="1579646"/>
            <a:chOff x="-2494836" y="1181890"/>
            <a:chExt cx="1408986" cy="1579646"/>
          </a:xfrm>
        </p:grpSpPr>
        <p:cxnSp>
          <p:nvCxnSpPr>
            <p:cNvPr id="74" name="Conector recto de flecha 73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Conector recto de flecha 74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CuadroTexto 75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CuadroTexto 76"/>
            <p:cNvSpPr txBox="1"/>
            <p:nvPr/>
          </p:nvSpPr>
          <p:spPr>
            <a:xfrm rot="16200000">
              <a:off x="-2613137" y="1787047"/>
              <a:ext cx="4828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8" name="Grupo 77"/>
          <p:cNvGrpSpPr/>
          <p:nvPr/>
        </p:nvGrpSpPr>
        <p:grpSpPr>
          <a:xfrm>
            <a:off x="5074234" y="3171622"/>
            <a:ext cx="1408986" cy="1579646"/>
            <a:chOff x="-2494836" y="1181890"/>
            <a:chExt cx="1408986" cy="1579646"/>
          </a:xfrm>
        </p:grpSpPr>
        <p:cxnSp>
          <p:nvCxnSpPr>
            <p:cNvPr id="79" name="Conector recto de flecha 78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ector recto de flecha 79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CuadroTexto 80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CuadroTexto 81"/>
            <p:cNvSpPr txBox="1"/>
            <p:nvPr/>
          </p:nvSpPr>
          <p:spPr>
            <a:xfrm rot="16200000">
              <a:off x="-2570658" y="1787047"/>
              <a:ext cx="39786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" name="Imagen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553" y="2997313"/>
            <a:ext cx="1534305" cy="1636282"/>
          </a:xfrm>
          <a:prstGeom prst="rect">
            <a:avLst/>
          </a:prstGeom>
        </p:spPr>
      </p:pic>
      <p:pic>
        <p:nvPicPr>
          <p:cNvPr id="8" name="Imagen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83409" y="2997313"/>
            <a:ext cx="1534305" cy="1636282"/>
          </a:xfrm>
          <a:prstGeom prst="rect">
            <a:avLst/>
          </a:prstGeom>
        </p:spPr>
      </p:pic>
      <p:pic>
        <p:nvPicPr>
          <p:cNvPr id="9" name="Imagen 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64654" y="2997313"/>
            <a:ext cx="1501856" cy="1636282"/>
          </a:xfrm>
          <a:prstGeom prst="rect">
            <a:avLst/>
          </a:prstGeom>
        </p:spPr>
      </p:pic>
      <p:pic>
        <p:nvPicPr>
          <p:cNvPr id="10" name="Imagen 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96764" y="2997313"/>
            <a:ext cx="1501856" cy="1636282"/>
          </a:xfrm>
          <a:prstGeom prst="rect">
            <a:avLst/>
          </a:prstGeom>
        </p:spPr>
      </p:pic>
      <p:grpSp>
        <p:nvGrpSpPr>
          <p:cNvPr id="83" name="Grupo 82"/>
          <p:cNvGrpSpPr/>
          <p:nvPr/>
        </p:nvGrpSpPr>
        <p:grpSpPr>
          <a:xfrm>
            <a:off x="210770" y="5076622"/>
            <a:ext cx="1408985" cy="1579646"/>
            <a:chOff x="-2494835" y="1181890"/>
            <a:chExt cx="1408985" cy="1579646"/>
          </a:xfrm>
        </p:grpSpPr>
        <p:cxnSp>
          <p:nvCxnSpPr>
            <p:cNvPr id="84" name="Conector recto de flecha 83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Conector recto de flecha 84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CuadroTexto 85"/>
            <p:cNvSpPr txBox="1"/>
            <p:nvPr/>
          </p:nvSpPr>
          <p:spPr>
            <a:xfrm rot="16200000">
              <a:off x="-2659624" y="1787047"/>
              <a:ext cx="57579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CuadroTexto 86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8" name="Grupo 87"/>
          <p:cNvGrpSpPr/>
          <p:nvPr/>
        </p:nvGrpSpPr>
        <p:grpSpPr>
          <a:xfrm>
            <a:off x="1877644" y="5076622"/>
            <a:ext cx="1408986" cy="1579646"/>
            <a:chOff x="-2494836" y="1181890"/>
            <a:chExt cx="1408986" cy="1579646"/>
          </a:xfrm>
        </p:grpSpPr>
        <p:cxnSp>
          <p:nvCxnSpPr>
            <p:cNvPr id="89" name="Conector recto de flecha 88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Conector recto de flecha 89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CuadroTexto 90"/>
            <p:cNvSpPr txBox="1"/>
            <p:nvPr/>
          </p:nvSpPr>
          <p:spPr>
            <a:xfrm rot="16200000">
              <a:off x="-2660426" y="1787047"/>
              <a:ext cx="577402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CuadroTexto 91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3" name="Grupo 92"/>
          <p:cNvGrpSpPr/>
          <p:nvPr/>
        </p:nvGrpSpPr>
        <p:grpSpPr>
          <a:xfrm>
            <a:off x="3474034" y="5076622"/>
            <a:ext cx="1408986" cy="1579646"/>
            <a:chOff x="-2494836" y="1181890"/>
            <a:chExt cx="1408986" cy="1579646"/>
          </a:xfrm>
        </p:grpSpPr>
        <p:cxnSp>
          <p:nvCxnSpPr>
            <p:cNvPr id="94" name="Conector recto de flecha 93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Conector recto de flecha 94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6" name="CuadroTexto 95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CuadroTexto 96"/>
            <p:cNvSpPr txBox="1"/>
            <p:nvPr/>
          </p:nvSpPr>
          <p:spPr>
            <a:xfrm rot="16200000">
              <a:off x="-2613137" y="1787047"/>
              <a:ext cx="48282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8" name="Grupo 97"/>
          <p:cNvGrpSpPr/>
          <p:nvPr/>
        </p:nvGrpSpPr>
        <p:grpSpPr>
          <a:xfrm>
            <a:off x="5083759" y="5076622"/>
            <a:ext cx="1408986" cy="1579646"/>
            <a:chOff x="-2494836" y="1181890"/>
            <a:chExt cx="1408986" cy="1579646"/>
          </a:xfrm>
        </p:grpSpPr>
        <p:cxnSp>
          <p:nvCxnSpPr>
            <p:cNvPr id="99" name="Conector recto de flecha 98"/>
            <p:cNvCxnSpPr/>
            <p:nvPr/>
          </p:nvCxnSpPr>
          <p:spPr>
            <a:xfrm flipH="1" flipV="1">
              <a:off x="-2371725" y="1181890"/>
              <a:ext cx="9526" cy="145653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ector recto de flecha 99"/>
            <p:cNvCxnSpPr/>
            <p:nvPr/>
          </p:nvCxnSpPr>
          <p:spPr>
            <a:xfrm>
              <a:off x="-2362199" y="2638426"/>
              <a:ext cx="127634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CuadroTexto 100"/>
            <p:cNvSpPr txBox="1"/>
            <p:nvPr/>
          </p:nvSpPr>
          <p:spPr>
            <a:xfrm>
              <a:off x="-2060259" y="2515315"/>
              <a:ext cx="56938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CuadroTexto 101"/>
            <p:cNvSpPr txBox="1"/>
            <p:nvPr/>
          </p:nvSpPr>
          <p:spPr>
            <a:xfrm rot="16200000">
              <a:off x="-2570658" y="1787047"/>
              <a:ext cx="397866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gM</a:t>
              </a:r>
              <a:endParaRPr lang="es-E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6" name="Imagen 1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7506" y="4912977"/>
            <a:ext cx="1520399" cy="1622376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990362" y="4912977"/>
            <a:ext cx="1520399" cy="1622376"/>
          </a:xfrm>
          <a:prstGeom prst="rect">
            <a:avLst/>
          </a:prstGeom>
        </p:spPr>
      </p:pic>
      <p:pic>
        <p:nvPicPr>
          <p:cNvPr id="19" name="Imagen 1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203717" y="4912977"/>
            <a:ext cx="1487950" cy="1622376"/>
          </a:xfrm>
          <a:prstGeom prst="rect">
            <a:avLst/>
          </a:prstGeom>
        </p:spPr>
      </p:pic>
      <p:pic>
        <p:nvPicPr>
          <p:cNvPr id="23" name="Imagen 2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571607" y="4912977"/>
            <a:ext cx="1487950" cy="1622376"/>
          </a:xfrm>
          <a:prstGeom prst="rect">
            <a:avLst/>
          </a:prstGeom>
        </p:spPr>
      </p:pic>
      <p:sp>
        <p:nvSpPr>
          <p:cNvPr id="103" name="CuadroTexto 102"/>
          <p:cNvSpPr txBox="1"/>
          <p:nvPr/>
        </p:nvSpPr>
        <p:spPr>
          <a:xfrm>
            <a:off x="50555" y="89502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smtClean="0"/>
              <a:t>A</a:t>
            </a:r>
            <a:endParaRPr lang="es-ES" sz="1600" b="1" dirty="0"/>
          </a:p>
        </p:txBody>
      </p:sp>
      <p:sp>
        <p:nvSpPr>
          <p:cNvPr id="104" name="CuadroTexto 103"/>
          <p:cNvSpPr txBox="1"/>
          <p:nvPr/>
        </p:nvSpPr>
        <p:spPr>
          <a:xfrm>
            <a:off x="50555" y="2864220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 smtClean="0"/>
              <a:t>B</a:t>
            </a:r>
            <a:endParaRPr lang="es-ES" sz="1600" b="1" dirty="0"/>
          </a:p>
        </p:txBody>
      </p:sp>
      <p:sp>
        <p:nvSpPr>
          <p:cNvPr id="105" name="CuadroTexto 104"/>
          <p:cNvSpPr txBox="1"/>
          <p:nvPr/>
        </p:nvSpPr>
        <p:spPr>
          <a:xfrm>
            <a:off x="55364" y="4787161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b="1" dirty="0"/>
              <a:t>C</a:t>
            </a:r>
          </a:p>
        </p:txBody>
      </p:sp>
      <p:sp>
        <p:nvSpPr>
          <p:cNvPr id="3" name="Rectángulo 2"/>
          <p:cNvSpPr/>
          <p:nvPr/>
        </p:nvSpPr>
        <p:spPr>
          <a:xfrm>
            <a:off x="198729" y="7116172"/>
            <a:ext cx="646054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low cytometry gating strategy for 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pleen (A), kidney (B) and peritoneum (C)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ukocytes. 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h sample, 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SC/FSC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files were used to define lymphoid gates. Single cells were 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dentified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y plotting FSC-H/FSC-A profiles. </a:t>
            </a:r>
            <a:r>
              <a:rPr lang="es-E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PI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criminat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v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a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PI n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gative cells within the singlet gate were used in all experiments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IgM</a:t>
            </a:r>
            <a:r>
              <a:rPr lang="en-GB" sz="1200" baseline="300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s were 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alysed from the </a:t>
            </a:r>
            <a:r>
              <a:rPr lang="en-GB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PI negative population.</a:t>
            </a:r>
            <a:endParaRPr lang="es-E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8" name="CuadroTexto 107"/>
          <p:cNvSpPr txBox="1"/>
          <p:nvPr/>
        </p:nvSpPr>
        <p:spPr>
          <a:xfrm>
            <a:off x="0" y="-1041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Figure </a:t>
            </a:r>
            <a:r>
              <a:rPr lang="es-ES" b="1" dirty="0" smtClean="0"/>
              <a:t>S1</a:t>
            </a:r>
            <a:endParaRPr lang="es-ES" b="1" dirty="0"/>
          </a:p>
        </p:txBody>
      </p:sp>
    </p:spTree>
    <p:extLst>
      <p:ext uri="{BB962C8B-B14F-4D97-AF65-F5344CB8AC3E}">
        <p14:creationId xmlns:p14="http://schemas.microsoft.com/office/powerpoint/2010/main" val="41892390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uadroTexto 7"/>
          <p:cNvSpPr txBox="1"/>
          <p:nvPr/>
        </p:nvSpPr>
        <p:spPr>
          <a:xfrm>
            <a:off x="1312724" y="937786"/>
            <a:ext cx="6607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Spleen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3112481" y="937786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Kidney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4760599" y="937786"/>
            <a:ext cx="9685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itoneum</a:t>
            </a:r>
            <a:endParaRPr lang="es-E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/>
          <p:cNvSpPr txBox="1"/>
          <p:nvPr/>
        </p:nvSpPr>
        <p:spPr>
          <a:xfrm>
            <a:off x="0" y="-10412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Figure </a:t>
            </a:r>
            <a:r>
              <a:rPr lang="es-ES" b="1" dirty="0" smtClean="0"/>
              <a:t>S2</a:t>
            </a:r>
            <a:endParaRPr lang="es-ES" b="1" dirty="0"/>
          </a:p>
        </p:txBody>
      </p:sp>
      <p:graphicFrame>
        <p:nvGraphicFramePr>
          <p:cNvPr id="14" name="Objeto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94933"/>
              </p:ext>
            </p:extLst>
          </p:nvPr>
        </p:nvGraphicFramePr>
        <p:xfrm>
          <a:off x="614974" y="976836"/>
          <a:ext cx="1668463" cy="23780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1" name="Prism 8" r:id="rId3" imgW="1899716" imgH="2707638" progId="Prism8.Document">
                  <p:embed/>
                </p:oleObj>
              </mc:Choice>
              <mc:Fallback>
                <p:oleObj name="Prism 8" r:id="rId3" imgW="1899716" imgH="27076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14974" y="976836"/>
                        <a:ext cx="1668463" cy="23780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to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35523057"/>
              </p:ext>
            </p:extLst>
          </p:nvPr>
        </p:nvGraphicFramePr>
        <p:xfrm>
          <a:off x="2425789" y="976836"/>
          <a:ext cx="1668463" cy="23780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2" name="Prism 8" r:id="rId5" imgW="1899716" imgH="2707638" progId="Prism8.Document">
                  <p:embed/>
                </p:oleObj>
              </mc:Choice>
              <mc:Fallback>
                <p:oleObj name="Prism 8" r:id="rId5" imgW="1899716" imgH="27076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25789" y="976836"/>
                        <a:ext cx="1668463" cy="23780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to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2413134"/>
              </p:ext>
            </p:extLst>
          </p:nvPr>
        </p:nvGraphicFramePr>
        <p:xfrm>
          <a:off x="4311738" y="976836"/>
          <a:ext cx="1620839" cy="23780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3" name="Prism 8" r:id="rId7" imgW="1844615" imgH="2707638" progId="Prism8.Document">
                  <p:embed/>
                </p:oleObj>
              </mc:Choice>
              <mc:Fallback>
                <p:oleObj name="Prism 8" r:id="rId7" imgW="1844615" imgH="270763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311738" y="976836"/>
                        <a:ext cx="1620839" cy="23780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Rectángulo 10"/>
          <p:cNvSpPr/>
          <p:nvPr/>
        </p:nvSpPr>
        <p:spPr>
          <a:xfrm>
            <a:off x="198000" y="3972828"/>
            <a:ext cx="64620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aphs showing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absolute number of IgM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spleen, kidney and peritoneal leukocyte cultures incubated in the presence or absence of the different 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. subtili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in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ukocyt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ur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 treat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1x10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fu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subtil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68 or CRS208 strains for 48 h. Controls not treated with bacteria were also included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reafter, the total number of cells was determined among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0000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ve lymphocytes gated following the strategy described in Fig. S1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ults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e expressed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 mean + SD (n=8)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e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erformed using a paired two-tailed Student's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, after checking the normality using Shapiro-Wilk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st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sterisk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note significant differences in stimulated cultures compared to control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lture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where *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≤ 0.05 and **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≤ 0.01.</a:t>
            </a:r>
            <a:endParaRPr lang="es-ES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6499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6</TotalTime>
  <Words>375</Words>
  <Application>Microsoft Office PowerPoint</Application>
  <PresentationFormat>A4 (210 x 297 mm)</PresentationFormat>
  <Paragraphs>95</Paragraphs>
  <Slides>4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e Office</vt:lpstr>
      <vt:lpstr>Prism 8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élix Docando Sánchez</dc:creator>
  <cp:lastModifiedBy>Carolina Tafalla</cp:lastModifiedBy>
  <cp:revision>64</cp:revision>
  <dcterms:created xsi:type="dcterms:W3CDTF">2022-04-11T09:43:27Z</dcterms:created>
  <dcterms:modified xsi:type="dcterms:W3CDTF">2022-04-13T12:29:42Z</dcterms:modified>
</cp:coreProperties>
</file>